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5" autoAdjust="0"/>
    <p:restoredTop sz="94660"/>
  </p:normalViewPr>
  <p:slideViewPr>
    <p:cSldViewPr snapToGrid="0">
      <p:cViewPr varScale="1">
        <p:scale>
          <a:sx n="77" d="100"/>
          <a:sy n="77" d="100"/>
        </p:scale>
        <p:origin x="48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050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413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198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064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133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772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13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374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512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349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12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B1C14-6D5C-49E7-A588-AB0FCCDD27DD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C20F52-5ED8-48A6-8737-3CAAC76DB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690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g"/><Relationship Id="rId5" Type="http://schemas.openxmlformats.org/officeDocument/2006/relationships/image" Target="../media/image9.jpeg"/><Relationship Id="rId4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14.jp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444" y="900517"/>
            <a:ext cx="2240280" cy="230124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00834" y="413359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A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4637" y="850704"/>
            <a:ext cx="1972056" cy="2551176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3922736" y="377868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B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78770" y="900518"/>
            <a:ext cx="1844040" cy="2301240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7620001" y="430061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C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1434" y="4282399"/>
            <a:ext cx="2551176" cy="2176272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2110639" y="378912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D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3291" y="4120000"/>
            <a:ext cx="3313176" cy="2551176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5993705" y="3676391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E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134272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358" y="1009973"/>
            <a:ext cx="2837688" cy="80467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018785" y="580373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F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0269" y="3520754"/>
            <a:ext cx="2788920" cy="269748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018786" y="3085578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G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8500" y="986424"/>
            <a:ext cx="3892296" cy="182880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4688913" y="54279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H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2258" y="3479794"/>
            <a:ext cx="3499104" cy="850392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4776595" y="303547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I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5283" y="5315796"/>
            <a:ext cx="4239768" cy="126187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3633" y="944777"/>
            <a:ext cx="4270248" cy="96012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4789119" y="486427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J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9173228" y="48016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K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5572" y="2697731"/>
            <a:ext cx="3846576" cy="1938528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9311015" y="2258861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L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622619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138" y="704714"/>
            <a:ext cx="4017264" cy="206654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457196" y="304801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M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290" y="3459084"/>
            <a:ext cx="2758440" cy="116738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507300" y="303547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N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890" y="5336506"/>
            <a:ext cx="3624072" cy="944880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1457196" y="4889327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O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6636" y="699829"/>
            <a:ext cx="3544824" cy="1024128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5603313" y="292275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P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4318" y="3398500"/>
            <a:ext cx="3544824" cy="1088136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5678469" y="2885162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Q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9558" y="5307508"/>
            <a:ext cx="3514344" cy="1228344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5690995" y="4839223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R</a:t>
            </a: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9787" y="722709"/>
            <a:ext cx="3514344" cy="1780032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9486379" y="304801"/>
            <a:ext cx="1565753" cy="35072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igure S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9036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38</Words>
  <Application>Microsoft Office PowerPoint</Application>
  <PresentationFormat>Widescreen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Emory Healthcar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feek Owonikoko</dc:creator>
  <cp:lastModifiedBy>Taofeek Owonikoko</cp:lastModifiedBy>
  <cp:revision>3</cp:revision>
  <dcterms:created xsi:type="dcterms:W3CDTF">2019-02-05T16:32:24Z</dcterms:created>
  <dcterms:modified xsi:type="dcterms:W3CDTF">2019-02-05T16:46:53Z</dcterms:modified>
</cp:coreProperties>
</file>